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5" r:id="rId2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2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35AE4F3-0201-500E-68C0-03A911BD8D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AB464A7-3F11-85A6-267E-E752658EEC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2947820-7B53-F4DE-CFBA-A8490D02D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083DCB1-FC8A-4B59-B639-50AA41391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5AB1928-825D-48DB-68FE-B7FE23131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43258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D1C8A5D-D95F-07A3-3FAC-778F7C7AB1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E209D60-22F3-DBEC-A1EF-7CA1C7EDD2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384A828-0720-7E0A-9E54-F7EC8B10A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A31E6DC-0262-365D-EF60-BE4D42D04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96797B9-D801-950A-308C-55DCCD1025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61362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F9F2476-DEF0-DF2E-57B8-53DBA7B5FB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02AE8CA-9858-A0F8-1E77-4AF2FC43CC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B12D45E-0A55-9B42-6BC1-CEF7EAEBD6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47F2EE5-A933-E391-3209-142CC954E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A95CEA8-BA48-5828-12D7-818F17F16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31792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CA48E1-FB94-F158-E91D-002E44F30D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DA4481D-6611-CE7C-8473-FC38EE476A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72FFA34-85CF-8239-DB01-7D02CCD446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8FE2C99-367A-0A60-6386-DBCA0B218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590EEDB-7293-8F5A-7E86-C56DFA0A6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05572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611E7C-2C7A-ADDC-89D3-481515416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D2DB4F3-2F23-229A-3311-5A42239AAE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E84331E-6A95-E46E-187B-D86433A5B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6365312-5FFF-CB64-4E02-C802AAF966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0567A35-1ACD-81D8-6D07-B6CE2E17D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80791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DBF55D0-CF45-10A1-1C39-4FE5D562B5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35C04FE-86C8-19A0-740E-432391E0D5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86896C8-7149-2E38-6C01-1073BF9184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A02E70C-7ACF-FE4F-8758-FB5F4513A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C8C25C2-D61E-680F-9997-1E07960BA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D80FE25-687C-73BD-CFF5-E48014BD8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234727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422E0B-3FD2-D9A2-4F48-5203F54B52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A401044-B613-71A9-A737-59219E9BE1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42B9F74-724C-6CDB-29C5-93A0904D64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AC23F206-FF2D-3BB9-414B-EDA1D034A8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1024DCC-53F5-A091-0D53-227C01BB8B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275D44E-0BED-B583-D624-C1A4A5297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E634ED3A-AF9A-450A-B6B6-E46E87E75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BC1674E4-E5E5-4768-1EC9-5F527BA5C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4910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F476D8-7F74-318E-00F0-46EA6D8DA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57589CFB-64FF-5EFB-DA61-64DC3273A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0ADD9D3-35C7-98C0-F8F2-55E68B682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55AAB13-2045-BF8A-2784-B9D18DFEF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072282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961874AB-5792-CD55-513C-5E1DEFB0C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A1C3CEFC-E71F-ADDB-4F0D-F118C0B09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C69991D-9F4D-2C7E-67FB-8052A9737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37571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CF33AA-808B-4904-2B08-980B431C54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2BF720D-CABD-9C0D-13D4-554DDEF0A0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9F07C8E-CAA9-52B4-38B0-CC6D6613E9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D89D186-974B-D892-5F0D-E577B5D44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0448E65-7FF6-EEA3-9F20-D797A632F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4F64B89-413D-AF60-553B-B9DC937C8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085771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4573513-CAB9-2DC5-5E1D-D54DCCF077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D0E496AF-F38A-8634-6F58-479203A8C4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8F4BF18-6B37-EA5E-2CC3-C72F9AA5F5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A897BDE-0205-1B5C-0EE4-4ADAAE286A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C57DFFA-1B0F-051D-E7CE-246077005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56D6CAD-D236-96C5-BF47-82BCA8011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08583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6FFEBAD-4C9D-9FE4-1392-FCEF98A85A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35A3278-070A-26D3-59A1-A3A16AD2FA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BE89FE9-8278-5002-06A6-157D97AFFE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82E5A9-514C-452B-ACC7-6E08DC43930B}" type="datetimeFigureOut">
              <a:rPr lang="es-CL" smtClean="0"/>
              <a:t>18-12-2025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93B5607-234B-896E-310A-CBDDDB96D8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9C7E1D8-62B2-00C6-B8BF-F74AAE50F6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DE8BBA-7B24-4228-9757-AFEBFF175D4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8104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E42C84-6BB7-A87F-8BAB-65A7A9290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3173" y="6167940"/>
            <a:ext cx="11179279" cy="542576"/>
          </a:xfrm>
        </p:spPr>
        <p:txBody>
          <a:bodyPr>
            <a:noAutofit/>
          </a:bodyPr>
          <a:lstStyle/>
          <a:p>
            <a: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Resistance (IMASCORE rating) to blackleg isolate JN2 in BC</a:t>
            </a:r>
            <a:r>
              <a:rPr lang="en-AU" sz="18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AU" sz="18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dividuals resulting from the cross </a:t>
            </a:r>
            <a:r>
              <a:rPr lang="en-AU" sz="18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 napus </a:t>
            </a:r>
            <a: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× </a:t>
            </a:r>
            <a:r>
              <a:rPr lang="en-AU" sz="18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 nigra</a:t>
            </a:r>
            <a: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llowed by two generations of backcrossing, showing resistance</a:t>
            </a:r>
            <a:r>
              <a:rPr lang="en-AU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susceptibility</a:t>
            </a:r>
            <a: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cores of individuals showing presence of each B-genome chromosome inherited from </a:t>
            </a:r>
            <a:r>
              <a:rPr lang="en-AU" sz="18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B. nigra</a:t>
            </a:r>
            <a:r>
              <a:rPr lang="en-AU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rent (B1 – B8).</a:t>
            </a:r>
            <a:br>
              <a:rPr lang="de-DE" sz="1600" dirty="0"/>
            </a:br>
            <a:endParaRPr lang="es-CL" sz="1600" dirty="0"/>
          </a:p>
        </p:txBody>
      </p:sp>
      <p:pic>
        <p:nvPicPr>
          <p:cNvPr id="5" name="Marcador de contenido 4" descr="Imagen que contiene Diagrama&#10;&#10;Descripción generada automáticamente">
            <a:extLst>
              <a:ext uri="{FF2B5EF4-FFF2-40B4-BE49-F238E27FC236}">
                <a16:creationId xmlns:a16="http://schemas.microsoft.com/office/drawing/2014/main" id="{101321BC-07C3-93C1-D3F7-939C200BE30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8" b="4829"/>
          <a:stretch/>
        </p:blipFill>
        <p:spPr>
          <a:xfrm>
            <a:off x="2500227" y="0"/>
            <a:ext cx="6688743" cy="5312280"/>
          </a:xfr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E7ACDFB4-9D04-BAB2-AFB8-A5D23BB4146D}"/>
              </a:ext>
            </a:extLst>
          </p:cNvPr>
          <p:cNvSpPr txBox="1"/>
          <p:nvPr/>
        </p:nvSpPr>
        <p:spPr>
          <a:xfrm rot="16200000">
            <a:off x="-138562" y="2413381"/>
            <a:ext cx="4694303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000" dirty="0"/>
              <a:t>IMASCORE</a:t>
            </a:r>
            <a:endParaRPr lang="es-CL" sz="2000" dirty="0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01FBA48B-7585-870D-9838-96B5DA99DA69}"/>
              </a:ext>
            </a:extLst>
          </p:cNvPr>
          <p:cNvSpPr txBox="1"/>
          <p:nvPr/>
        </p:nvSpPr>
        <p:spPr>
          <a:xfrm>
            <a:off x="2806444" y="5387165"/>
            <a:ext cx="63403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2000" dirty="0" err="1"/>
              <a:t>Chromosome</a:t>
            </a:r>
            <a:endParaRPr lang="es-CL" sz="2000" dirty="0"/>
          </a:p>
        </p:txBody>
      </p:sp>
    </p:spTree>
    <p:extLst>
      <p:ext uri="{BB962C8B-B14F-4D97-AF65-F5344CB8AC3E}">
        <p14:creationId xmlns:p14="http://schemas.microsoft.com/office/powerpoint/2010/main" val="123999703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6</TotalTime>
  <Words>62</Words>
  <Application>Microsoft Office PowerPoint</Application>
  <PresentationFormat>Panorámica</PresentationFormat>
  <Paragraphs>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e Office</vt:lpstr>
      <vt:lpstr>Supplementary Figure 2: Resistance (IMASCORE rating) to blackleg isolate JN2 in BC2F1 individuals resulting from the cross B. napus × B. nigra followed by two generations of backcrossing, showing resistance/susceptibility scores of individuals showing presence of each B-genome chromosome inherited from the B. nigra parent (B1 – B8)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ula Andrea Vásquez Teuber</dc:creator>
  <cp:lastModifiedBy>Paula Andrea Vásquez Teuber</cp:lastModifiedBy>
  <cp:revision>3</cp:revision>
  <dcterms:created xsi:type="dcterms:W3CDTF">2025-03-26T13:42:46Z</dcterms:created>
  <dcterms:modified xsi:type="dcterms:W3CDTF">2025-12-18T13:19:00Z</dcterms:modified>
</cp:coreProperties>
</file>